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7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BA16A7E-8056-4022-8685-27C460281C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80C76820-21E5-4690-8FB2-582FDDA8BD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ACBCC88-8A0D-4012-96BA-4EA6B828C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E85E6-3212-4F4B-B79F-A1DB3E9B08D2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9DC8CFF-BE16-41B3-8335-936A1B3986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B708999-17FD-46C8-9149-E8382F305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E45CF-DC93-4525-A0E4-2F406B9F91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0601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CBF4DBF-FD4F-46A6-928A-DD986C1FFF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3B522F2-D01D-4137-8EB6-3207D6F11C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10F4D12-09D1-4F6F-80B8-CE3D10B484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E85E6-3212-4F4B-B79F-A1DB3E9B08D2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F43B57B-D4D0-464A-9906-6BDB5B3263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D5AA5EB-7893-41D6-B6A0-F2B2661D73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E45CF-DC93-4525-A0E4-2F406B9F91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7582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985D1CF-78BF-4954-A8C8-EC502A2235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F110D984-BC89-4EA3-890A-F25F6670A7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4F4578C-7986-47AF-8C5B-808D136B9E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E85E6-3212-4F4B-B79F-A1DB3E9B08D2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4B45CF0-20C0-4EE9-9B12-8DD98D3760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1E06048-C021-47D4-B02B-B4D5B5728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E45CF-DC93-4525-A0E4-2F406B9F91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0431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0043236-10E0-4439-B22C-5518C1451A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A686D95-EDD6-4E9D-A154-0EEB59B1F8F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8EE9805-69A8-423F-BBA0-632D28DCD8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E85E6-3212-4F4B-B79F-A1DB3E9B08D2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C71B3D1-3E0D-400E-88CC-671E69961D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8DC15C5-36BB-485D-B328-B388EE176A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E45CF-DC93-4525-A0E4-2F406B9F91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3315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1B3C2CD-D5A7-4153-9D24-A250026260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1DB9A43-BE89-4A50-9AFC-476F45F991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5D49E13-977F-4949-8D8F-F0D83C3283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E85E6-3212-4F4B-B79F-A1DB3E9B08D2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994D35B-F7AB-4AE8-8B2D-58E7AE8625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0C39725-1FF6-448D-B575-9F59E6EAFD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E45CF-DC93-4525-A0E4-2F406B9F91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59450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685AF0E-BD2A-46D4-83CD-8BA71C1FC8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D1BF3A0-2E54-405F-A9CF-D88368377E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26CDD236-E0EB-4CB3-832F-DEBA1861B2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3B61BFD-69C1-4267-8DA6-BD723A9A2C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E85E6-3212-4F4B-B79F-A1DB3E9B08D2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79BFCFA-C35B-4BF9-9F96-791B249B6F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D04D880-92E4-40D9-B260-F615A6759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E45CF-DC93-4525-A0E4-2F406B9F91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4888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B45E5AD-F3F9-4749-B7DB-1D6E42B2A9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CD8DB1A-38C7-4155-8F63-62A73800B2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A68D6C7-E0F3-478F-AA86-860C61291C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0C08E571-F208-4601-BD37-358305F68C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A0B997E0-E09A-4C00-9D5B-BBEBB8C545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58FD3CF8-04E4-4041-AB6A-D02ECF6BE4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E85E6-3212-4F4B-B79F-A1DB3E9B08D2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1553F12F-C8AF-47CC-A477-B2E03C45EC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747DD48E-F03D-4A4A-ADF0-7C2B092C9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E45CF-DC93-4525-A0E4-2F406B9F91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757972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288CA64-0EDF-431F-84A3-30FFBA82DE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A397348A-E2C2-432A-A7B5-DC5E6DC659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E85E6-3212-4F4B-B79F-A1DB3E9B08D2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54B2DB38-2D61-4B38-A491-8091234083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032C1812-DD6A-4387-A9A5-1D91F95C49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E45CF-DC93-4525-A0E4-2F406B9F91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7313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1392FB70-7A51-4D67-AF6C-25E4A75E1F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E85E6-3212-4F4B-B79F-A1DB3E9B08D2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B161478B-6056-49B0-BEEA-E0B283E445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394D2A52-B9AC-4809-8172-D98FB5788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E45CF-DC93-4525-A0E4-2F406B9F91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5333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6AD563F-D895-479D-B32D-36CEC34BD3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7AA573B-DC8B-4F50-A34F-6D5832845D4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E276667-0774-4E19-AF0B-CE8FB808A1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59186EB-EF56-4034-B5E8-216D211882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E85E6-3212-4F4B-B79F-A1DB3E9B08D2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CFAFD60-BDCD-4599-A3C9-FD92CBB9A2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0D2A321-397E-4F3A-85F2-0FDF95C53E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E45CF-DC93-4525-A0E4-2F406B9F91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3390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EB19F39-84E1-440A-838C-CF621B72DE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92235421-7952-4D0B-9F89-7FF2A42E124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F0FE8EB-8D23-4548-AC09-6343E9D749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3BA0570-DB42-479D-9514-8111FAAEF9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E85E6-3212-4F4B-B79F-A1DB3E9B08D2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7FE5168-74C8-43B4-99AE-A3C3600625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0554C49-2359-4FA5-857C-E7E00E1619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E45CF-DC93-4525-A0E4-2F406B9F91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85260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E7AB2BB5-F722-47C8-8475-32C972085A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18527EC-0C02-4D3B-B563-A1607E36BB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243C2C3-ED80-465E-AB77-490BC2D127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1E85E6-3212-4F4B-B79F-A1DB3E9B08D2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0BBD62B-08A5-4D83-8F60-E4535697A44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93A6639-8106-45BD-953B-495296FD48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8E45CF-DC93-4525-A0E4-2F406B9F91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755745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8AE796A1-FE9B-449D-A23B-F073C05C2D4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437" y="317988"/>
            <a:ext cx="6382512" cy="95707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4655C7C-A494-47EC-B248-BC4FC66DDDC7}"/>
              </a:ext>
            </a:extLst>
          </p:cNvPr>
          <p:cNvSpPr txBox="1"/>
          <p:nvPr/>
        </p:nvSpPr>
        <p:spPr>
          <a:xfrm>
            <a:off x="187437" y="1275060"/>
            <a:ext cx="60113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 of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omozygous T-DNA insertion lines. T-DNA-specific primer and gene-specific primers were used for PCR to detect homozygous lines. (A) SALK_003729 (B) SALK_034157 (C) SALK_088514 (D) SALK_100993 (E) SALK_201649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4574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55</Words>
  <Application>Microsoft Office PowerPoint</Application>
  <PresentationFormat>와이드스크린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만보</dc:creator>
  <cp:lastModifiedBy>이만보</cp:lastModifiedBy>
  <cp:revision>3</cp:revision>
  <dcterms:created xsi:type="dcterms:W3CDTF">2023-03-23T06:15:07Z</dcterms:created>
  <dcterms:modified xsi:type="dcterms:W3CDTF">2023-04-09T12:27:13Z</dcterms:modified>
</cp:coreProperties>
</file>